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AAA59C-2D9A-4D40-8414-C6252E6F24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47F42E-8E1E-4405-9C11-169F59F1E4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CB0253-F6EC-47B3-BC69-FDE9C5268C8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986B3A-EA5B-4391-BC97-17D6B8B1FD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FB01A4-8575-4D8E-9434-F0258D29F6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70A627-2522-4890-A8DF-952885F62C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44C389-CC6B-44DB-BBE8-CBA7225939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A87361-5C74-4B49-B8A5-0506A41470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1BBDAB-8D35-4E77-B7C7-DF8DAE3D01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521848-03CE-4F7A-AA08-5BBD0F624C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2B092C-6D02-4F67-B585-76A34868BE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8B858A-4D07-49C7-B127-6B05CA4CE7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1AFD20A-1C95-4598-BFEE-2704FC6BF428}" type="datetime">
              <a:rPr b="0" lang="it-IT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3DAB55E-5F91-45B1-8FCD-83D8DEE905E8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3"/>
          <p:cNvSpPr/>
          <p:nvPr/>
        </p:nvSpPr>
        <p:spPr>
          <a:xfrm>
            <a:off x="630360" y="4351320"/>
            <a:ext cx="73706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upplementary Figure 2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Functional categorization of Tentative Consensus (TCs) showing differential hybridization signals in IL10-1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vs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M82. Categorization was performed according to GO Molecular Function (MF) vocabulary as retrieved through Blast2GO Gene Ontology mapping. Differentially expressed TCs were categorized as split into up-regulated and down-regulated TCs and  calculated as percentage of the total number of classifications 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uppo 5"/>
          <p:cNvGrpSpPr/>
          <p:nvPr/>
        </p:nvGrpSpPr>
        <p:grpSpPr>
          <a:xfrm>
            <a:off x="6570720" y="2062080"/>
            <a:ext cx="1461600" cy="482040"/>
            <a:chOff x="6570720" y="2062080"/>
            <a:chExt cx="1461600" cy="482040"/>
          </a:xfrm>
        </p:grpSpPr>
        <p:sp>
          <p:nvSpPr>
            <p:cNvPr id="43" name="Rettangolo 6"/>
            <p:cNvSpPr/>
            <p:nvPr/>
          </p:nvSpPr>
          <p:spPr>
            <a:xfrm>
              <a:off x="6570720" y="2133360"/>
              <a:ext cx="107640" cy="1094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ttangolo 7"/>
            <p:cNvSpPr/>
            <p:nvPr/>
          </p:nvSpPr>
          <p:spPr>
            <a:xfrm>
              <a:off x="6570720" y="2359080"/>
              <a:ext cx="107640" cy="108000"/>
            </a:xfrm>
            <a:prstGeom prst="rect">
              <a:avLst/>
            </a:prstGeom>
            <a:solidFill>
              <a:srgbClr val="7f7f7f"/>
            </a:solidFill>
            <a:ln w="255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CasellaDiTesto 8"/>
            <p:cNvSpPr/>
            <p:nvPr/>
          </p:nvSpPr>
          <p:spPr>
            <a:xfrm>
              <a:off x="6680880" y="2062080"/>
              <a:ext cx="1238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Upregulated TC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CasellaDiTesto 9"/>
            <p:cNvSpPr/>
            <p:nvPr/>
          </p:nvSpPr>
          <p:spPr>
            <a:xfrm>
              <a:off x="6681240" y="2282760"/>
              <a:ext cx="1351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wnregulated</a:t>
              </a:r>
              <a:r>
                <a:rPr b="0" lang="it-IT" sz="1100" spc="-1" strike="noStrike">
                  <a:solidFill>
                    <a:srgbClr val="000000"/>
                  </a:solidFill>
                  <a:latin typeface="Calibri"/>
                </a:rPr>
                <a:t> TC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47" name="Grafico 15" descr=""/>
          <p:cNvPicPr/>
          <p:nvPr/>
        </p:nvPicPr>
        <p:blipFill>
          <a:blip r:embed="rId1"/>
          <a:stretch/>
        </p:blipFill>
        <p:spPr>
          <a:xfrm>
            <a:off x="622440" y="2054160"/>
            <a:ext cx="5692680" cy="2243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9T10:50:49Z</dcterms:created>
  <dc:creator>amalia  barone</dc:creator>
  <dc:description/>
  <dc:language>en-US</dc:language>
  <cp:lastModifiedBy>Amalia</cp:lastModifiedBy>
  <dcterms:modified xsi:type="dcterms:W3CDTF">2011-12-29T14:45:42Z</dcterms:modified>
  <cp:revision>6</cp:revision>
  <dc:subject/>
  <dc:title>Diapositiva 1</dc:title>
</cp:coreProperties>
</file>